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5" r:id="rId2"/>
  </p:sldIdLst>
  <p:sldSz cx="6119813" cy="8099425"/>
  <p:notesSz cx="5662613" cy="764222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551" userDrawn="1">
          <p15:clr>
            <a:srgbClr val="A4A3A4"/>
          </p15:clr>
        </p15:guide>
        <p15:guide id="2" pos="192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3594" autoAdjust="0"/>
    <p:restoredTop sz="94660"/>
  </p:normalViewPr>
  <p:slideViewPr>
    <p:cSldViewPr>
      <p:cViewPr varScale="1">
        <p:scale>
          <a:sx n="133" d="100"/>
          <a:sy n="133" d="100"/>
        </p:scale>
        <p:origin x="2088" y="138"/>
      </p:cViewPr>
      <p:guideLst>
        <p:guide orient="horz" pos="2551"/>
        <p:guide pos="192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58986" y="1325531"/>
            <a:ext cx="5201841" cy="2819800"/>
          </a:xfrm>
        </p:spPr>
        <p:txBody>
          <a:bodyPr anchor="b"/>
          <a:lstStyle>
            <a:lvl1pPr algn="ctr">
              <a:defRPr sz="4016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64977" y="4254073"/>
            <a:ext cx="4589860" cy="1955486"/>
          </a:xfrm>
        </p:spPr>
        <p:txBody>
          <a:bodyPr/>
          <a:lstStyle>
            <a:lvl1pPr marL="0" indent="0" algn="ctr">
              <a:buNone/>
              <a:defRPr sz="1606"/>
            </a:lvl1pPr>
            <a:lvl2pPr marL="306004" indent="0" algn="ctr">
              <a:buNone/>
              <a:defRPr sz="1339"/>
            </a:lvl2pPr>
            <a:lvl3pPr marL="612008" indent="0" algn="ctr">
              <a:buNone/>
              <a:defRPr sz="1205"/>
            </a:lvl3pPr>
            <a:lvl4pPr marL="918012" indent="0" algn="ctr">
              <a:buNone/>
              <a:defRPr sz="1071"/>
            </a:lvl4pPr>
            <a:lvl5pPr marL="1224016" indent="0" algn="ctr">
              <a:buNone/>
              <a:defRPr sz="1071"/>
            </a:lvl5pPr>
            <a:lvl6pPr marL="1530020" indent="0" algn="ctr">
              <a:buNone/>
              <a:defRPr sz="1071"/>
            </a:lvl6pPr>
            <a:lvl7pPr marL="1836024" indent="0" algn="ctr">
              <a:buNone/>
              <a:defRPr sz="1071"/>
            </a:lvl7pPr>
            <a:lvl8pPr marL="2142028" indent="0" algn="ctr">
              <a:buNone/>
              <a:defRPr sz="1071"/>
            </a:lvl8pPr>
            <a:lvl9pPr marL="2448032" indent="0" algn="ctr">
              <a:buNone/>
              <a:defRPr sz="1071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D03932-EA21-45EA-9817-314F5CFB8F6D}" type="datetimeFigureOut">
              <a:rPr lang="en-US" smtClean="0"/>
              <a:t>7/15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F56215-095D-41DD-A57D-B0180E7C0D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29177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D03932-EA21-45EA-9817-314F5CFB8F6D}" type="datetimeFigureOut">
              <a:rPr lang="en-US" smtClean="0"/>
              <a:t>7/15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F56215-095D-41DD-A57D-B0180E7C0D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3870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379491" y="431220"/>
            <a:ext cx="1319585" cy="686388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20738" y="431220"/>
            <a:ext cx="3882256" cy="686388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D03932-EA21-45EA-9817-314F5CFB8F6D}" type="datetimeFigureOut">
              <a:rPr lang="en-US" smtClean="0"/>
              <a:t>7/15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F56215-095D-41DD-A57D-B0180E7C0D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73073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D03932-EA21-45EA-9817-314F5CFB8F6D}" type="datetimeFigureOut">
              <a:rPr lang="en-US" smtClean="0"/>
              <a:t>7/15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F56215-095D-41DD-A57D-B0180E7C0D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17759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17550" y="2019234"/>
            <a:ext cx="5278339" cy="3369135"/>
          </a:xfrm>
        </p:spPr>
        <p:txBody>
          <a:bodyPr anchor="b"/>
          <a:lstStyle>
            <a:lvl1pPr>
              <a:defRPr sz="4016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17550" y="5420242"/>
            <a:ext cx="5278339" cy="1771749"/>
          </a:xfrm>
        </p:spPr>
        <p:txBody>
          <a:bodyPr/>
          <a:lstStyle>
            <a:lvl1pPr marL="0" indent="0">
              <a:buNone/>
              <a:defRPr sz="1606">
                <a:solidFill>
                  <a:schemeClr val="tx1"/>
                </a:solidFill>
              </a:defRPr>
            </a:lvl1pPr>
            <a:lvl2pPr marL="306004" indent="0">
              <a:buNone/>
              <a:defRPr sz="1339">
                <a:solidFill>
                  <a:schemeClr val="tx1">
                    <a:tint val="75000"/>
                  </a:schemeClr>
                </a:solidFill>
              </a:defRPr>
            </a:lvl2pPr>
            <a:lvl3pPr marL="612008" indent="0">
              <a:buNone/>
              <a:defRPr sz="1205">
                <a:solidFill>
                  <a:schemeClr val="tx1">
                    <a:tint val="75000"/>
                  </a:schemeClr>
                </a:solidFill>
              </a:defRPr>
            </a:lvl3pPr>
            <a:lvl4pPr marL="918012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4pPr>
            <a:lvl5pPr marL="1224016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5pPr>
            <a:lvl6pPr marL="1530020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6pPr>
            <a:lvl7pPr marL="1836024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7pPr>
            <a:lvl8pPr marL="2142028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8pPr>
            <a:lvl9pPr marL="2448032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D03932-EA21-45EA-9817-314F5CFB8F6D}" type="datetimeFigureOut">
              <a:rPr lang="en-US" smtClean="0"/>
              <a:t>7/15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F56215-095D-41DD-A57D-B0180E7C0D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44740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20737" y="2156097"/>
            <a:ext cx="2600921" cy="5139011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098155" y="2156097"/>
            <a:ext cx="2600921" cy="5139011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D03932-EA21-45EA-9817-314F5CFB8F6D}" type="datetimeFigureOut">
              <a:rPr lang="en-US" smtClean="0"/>
              <a:t>7/15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F56215-095D-41DD-A57D-B0180E7C0D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95487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431221"/>
            <a:ext cx="5278339" cy="1565514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1535" y="1985485"/>
            <a:ext cx="2588967" cy="973055"/>
          </a:xfrm>
        </p:spPr>
        <p:txBody>
          <a:bodyPr anchor="b"/>
          <a:lstStyle>
            <a:lvl1pPr marL="0" indent="0">
              <a:buNone/>
              <a:defRPr sz="1606" b="1"/>
            </a:lvl1pPr>
            <a:lvl2pPr marL="306004" indent="0">
              <a:buNone/>
              <a:defRPr sz="1339" b="1"/>
            </a:lvl2pPr>
            <a:lvl3pPr marL="612008" indent="0">
              <a:buNone/>
              <a:defRPr sz="1205" b="1"/>
            </a:lvl3pPr>
            <a:lvl4pPr marL="918012" indent="0">
              <a:buNone/>
              <a:defRPr sz="1071" b="1"/>
            </a:lvl4pPr>
            <a:lvl5pPr marL="1224016" indent="0">
              <a:buNone/>
              <a:defRPr sz="1071" b="1"/>
            </a:lvl5pPr>
            <a:lvl6pPr marL="1530020" indent="0">
              <a:buNone/>
              <a:defRPr sz="1071" b="1"/>
            </a:lvl6pPr>
            <a:lvl7pPr marL="1836024" indent="0">
              <a:buNone/>
              <a:defRPr sz="1071" b="1"/>
            </a:lvl7pPr>
            <a:lvl8pPr marL="2142028" indent="0">
              <a:buNone/>
              <a:defRPr sz="1071" b="1"/>
            </a:lvl8pPr>
            <a:lvl9pPr marL="2448032" indent="0">
              <a:buNone/>
              <a:defRPr sz="1071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21535" y="2958540"/>
            <a:ext cx="2588967" cy="4351567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098155" y="1985485"/>
            <a:ext cx="2601718" cy="973055"/>
          </a:xfrm>
        </p:spPr>
        <p:txBody>
          <a:bodyPr anchor="b"/>
          <a:lstStyle>
            <a:lvl1pPr marL="0" indent="0">
              <a:buNone/>
              <a:defRPr sz="1606" b="1"/>
            </a:lvl1pPr>
            <a:lvl2pPr marL="306004" indent="0">
              <a:buNone/>
              <a:defRPr sz="1339" b="1"/>
            </a:lvl2pPr>
            <a:lvl3pPr marL="612008" indent="0">
              <a:buNone/>
              <a:defRPr sz="1205" b="1"/>
            </a:lvl3pPr>
            <a:lvl4pPr marL="918012" indent="0">
              <a:buNone/>
              <a:defRPr sz="1071" b="1"/>
            </a:lvl4pPr>
            <a:lvl5pPr marL="1224016" indent="0">
              <a:buNone/>
              <a:defRPr sz="1071" b="1"/>
            </a:lvl5pPr>
            <a:lvl6pPr marL="1530020" indent="0">
              <a:buNone/>
              <a:defRPr sz="1071" b="1"/>
            </a:lvl6pPr>
            <a:lvl7pPr marL="1836024" indent="0">
              <a:buNone/>
              <a:defRPr sz="1071" b="1"/>
            </a:lvl7pPr>
            <a:lvl8pPr marL="2142028" indent="0">
              <a:buNone/>
              <a:defRPr sz="1071" b="1"/>
            </a:lvl8pPr>
            <a:lvl9pPr marL="2448032" indent="0">
              <a:buNone/>
              <a:defRPr sz="1071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098155" y="2958540"/>
            <a:ext cx="2601718" cy="4351567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D03932-EA21-45EA-9817-314F5CFB8F6D}" type="datetimeFigureOut">
              <a:rPr lang="en-US" smtClean="0"/>
              <a:t>7/15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F56215-095D-41DD-A57D-B0180E7C0D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44732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D03932-EA21-45EA-9817-314F5CFB8F6D}" type="datetimeFigureOut">
              <a:rPr lang="en-US" smtClean="0"/>
              <a:t>7/15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F56215-095D-41DD-A57D-B0180E7C0D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10093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D03932-EA21-45EA-9817-314F5CFB8F6D}" type="datetimeFigureOut">
              <a:rPr lang="en-US" smtClean="0"/>
              <a:t>7/15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F56215-095D-41DD-A57D-B0180E7C0D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44257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539962"/>
            <a:ext cx="1973799" cy="1889866"/>
          </a:xfrm>
        </p:spPr>
        <p:txBody>
          <a:bodyPr anchor="b"/>
          <a:lstStyle>
            <a:lvl1pPr>
              <a:defRPr sz="2142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01718" y="1166169"/>
            <a:ext cx="3098155" cy="5755841"/>
          </a:xfrm>
        </p:spPr>
        <p:txBody>
          <a:bodyPr/>
          <a:lstStyle>
            <a:lvl1pPr>
              <a:defRPr sz="2142"/>
            </a:lvl1pPr>
            <a:lvl2pPr>
              <a:defRPr sz="1874"/>
            </a:lvl2pPr>
            <a:lvl3pPr>
              <a:defRPr sz="1606"/>
            </a:lvl3pPr>
            <a:lvl4pPr>
              <a:defRPr sz="1339"/>
            </a:lvl4pPr>
            <a:lvl5pPr>
              <a:defRPr sz="1339"/>
            </a:lvl5pPr>
            <a:lvl6pPr>
              <a:defRPr sz="1339"/>
            </a:lvl6pPr>
            <a:lvl7pPr>
              <a:defRPr sz="1339"/>
            </a:lvl7pPr>
            <a:lvl8pPr>
              <a:defRPr sz="1339"/>
            </a:lvl8pPr>
            <a:lvl9pPr>
              <a:defRPr sz="1339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1534" y="2429828"/>
            <a:ext cx="1973799" cy="4501556"/>
          </a:xfrm>
        </p:spPr>
        <p:txBody>
          <a:bodyPr/>
          <a:lstStyle>
            <a:lvl1pPr marL="0" indent="0">
              <a:buNone/>
              <a:defRPr sz="1071"/>
            </a:lvl1pPr>
            <a:lvl2pPr marL="306004" indent="0">
              <a:buNone/>
              <a:defRPr sz="937"/>
            </a:lvl2pPr>
            <a:lvl3pPr marL="612008" indent="0">
              <a:buNone/>
              <a:defRPr sz="803"/>
            </a:lvl3pPr>
            <a:lvl4pPr marL="918012" indent="0">
              <a:buNone/>
              <a:defRPr sz="669"/>
            </a:lvl4pPr>
            <a:lvl5pPr marL="1224016" indent="0">
              <a:buNone/>
              <a:defRPr sz="669"/>
            </a:lvl5pPr>
            <a:lvl6pPr marL="1530020" indent="0">
              <a:buNone/>
              <a:defRPr sz="669"/>
            </a:lvl6pPr>
            <a:lvl7pPr marL="1836024" indent="0">
              <a:buNone/>
              <a:defRPr sz="669"/>
            </a:lvl7pPr>
            <a:lvl8pPr marL="2142028" indent="0">
              <a:buNone/>
              <a:defRPr sz="669"/>
            </a:lvl8pPr>
            <a:lvl9pPr marL="2448032" indent="0">
              <a:buNone/>
              <a:defRPr sz="669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D03932-EA21-45EA-9817-314F5CFB8F6D}" type="datetimeFigureOut">
              <a:rPr lang="en-US" smtClean="0"/>
              <a:t>7/15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F56215-095D-41DD-A57D-B0180E7C0D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7795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539962"/>
            <a:ext cx="1973799" cy="1889866"/>
          </a:xfrm>
        </p:spPr>
        <p:txBody>
          <a:bodyPr anchor="b"/>
          <a:lstStyle>
            <a:lvl1pPr>
              <a:defRPr sz="2142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601718" y="1166169"/>
            <a:ext cx="3098155" cy="5755841"/>
          </a:xfrm>
        </p:spPr>
        <p:txBody>
          <a:bodyPr anchor="t"/>
          <a:lstStyle>
            <a:lvl1pPr marL="0" indent="0">
              <a:buNone/>
              <a:defRPr sz="2142"/>
            </a:lvl1pPr>
            <a:lvl2pPr marL="306004" indent="0">
              <a:buNone/>
              <a:defRPr sz="1874"/>
            </a:lvl2pPr>
            <a:lvl3pPr marL="612008" indent="0">
              <a:buNone/>
              <a:defRPr sz="1606"/>
            </a:lvl3pPr>
            <a:lvl4pPr marL="918012" indent="0">
              <a:buNone/>
              <a:defRPr sz="1339"/>
            </a:lvl4pPr>
            <a:lvl5pPr marL="1224016" indent="0">
              <a:buNone/>
              <a:defRPr sz="1339"/>
            </a:lvl5pPr>
            <a:lvl6pPr marL="1530020" indent="0">
              <a:buNone/>
              <a:defRPr sz="1339"/>
            </a:lvl6pPr>
            <a:lvl7pPr marL="1836024" indent="0">
              <a:buNone/>
              <a:defRPr sz="1339"/>
            </a:lvl7pPr>
            <a:lvl8pPr marL="2142028" indent="0">
              <a:buNone/>
              <a:defRPr sz="1339"/>
            </a:lvl8pPr>
            <a:lvl9pPr marL="2448032" indent="0">
              <a:buNone/>
              <a:defRPr sz="1339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1534" y="2429828"/>
            <a:ext cx="1973799" cy="4501556"/>
          </a:xfrm>
        </p:spPr>
        <p:txBody>
          <a:bodyPr/>
          <a:lstStyle>
            <a:lvl1pPr marL="0" indent="0">
              <a:buNone/>
              <a:defRPr sz="1071"/>
            </a:lvl1pPr>
            <a:lvl2pPr marL="306004" indent="0">
              <a:buNone/>
              <a:defRPr sz="937"/>
            </a:lvl2pPr>
            <a:lvl3pPr marL="612008" indent="0">
              <a:buNone/>
              <a:defRPr sz="803"/>
            </a:lvl3pPr>
            <a:lvl4pPr marL="918012" indent="0">
              <a:buNone/>
              <a:defRPr sz="669"/>
            </a:lvl4pPr>
            <a:lvl5pPr marL="1224016" indent="0">
              <a:buNone/>
              <a:defRPr sz="669"/>
            </a:lvl5pPr>
            <a:lvl6pPr marL="1530020" indent="0">
              <a:buNone/>
              <a:defRPr sz="669"/>
            </a:lvl6pPr>
            <a:lvl7pPr marL="1836024" indent="0">
              <a:buNone/>
              <a:defRPr sz="669"/>
            </a:lvl7pPr>
            <a:lvl8pPr marL="2142028" indent="0">
              <a:buNone/>
              <a:defRPr sz="669"/>
            </a:lvl8pPr>
            <a:lvl9pPr marL="2448032" indent="0">
              <a:buNone/>
              <a:defRPr sz="669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D03932-EA21-45EA-9817-314F5CFB8F6D}" type="datetimeFigureOut">
              <a:rPr lang="en-US" smtClean="0"/>
              <a:t>7/15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F56215-095D-41DD-A57D-B0180E7C0D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49213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20737" y="431221"/>
            <a:ext cx="5278339" cy="156551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0737" y="2156097"/>
            <a:ext cx="5278339" cy="513901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20737" y="7506969"/>
            <a:ext cx="1376958" cy="43121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9D03932-EA21-45EA-9817-314F5CFB8F6D}" type="datetimeFigureOut">
              <a:rPr lang="en-US" smtClean="0"/>
              <a:t>7/15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027188" y="7506969"/>
            <a:ext cx="2065437" cy="43121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322118" y="7506969"/>
            <a:ext cx="1376958" cy="43121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F56215-095D-41DD-A57D-B0180E7C0D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00390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12008" rtl="0" eaLnBrk="1" latinLnBrk="0" hangingPunct="1">
        <a:lnSpc>
          <a:spcPct val="90000"/>
        </a:lnSpc>
        <a:spcBef>
          <a:spcPct val="0"/>
        </a:spcBef>
        <a:buNone/>
        <a:defRPr sz="294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3002" indent="-153002" algn="l" defTabSz="612008" rtl="0" eaLnBrk="1" latinLnBrk="0" hangingPunct="1">
        <a:lnSpc>
          <a:spcPct val="90000"/>
        </a:lnSpc>
        <a:spcBef>
          <a:spcPts val="669"/>
        </a:spcBef>
        <a:buFont typeface="Arial" panose="020B0604020202020204" pitchFamily="34" charset="0"/>
        <a:buChar char="•"/>
        <a:defRPr sz="1874" kern="1200">
          <a:solidFill>
            <a:schemeClr val="tx1"/>
          </a:solidFill>
          <a:latin typeface="+mn-lt"/>
          <a:ea typeface="+mn-ea"/>
          <a:cs typeface="+mn-cs"/>
        </a:defRPr>
      </a:lvl1pPr>
      <a:lvl2pPr marL="459006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606" kern="1200">
          <a:solidFill>
            <a:schemeClr val="tx1"/>
          </a:solidFill>
          <a:latin typeface="+mn-lt"/>
          <a:ea typeface="+mn-ea"/>
          <a:cs typeface="+mn-cs"/>
        </a:defRPr>
      </a:lvl2pPr>
      <a:lvl3pPr marL="765010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339" kern="1200">
          <a:solidFill>
            <a:schemeClr val="tx1"/>
          </a:solidFill>
          <a:latin typeface="+mn-lt"/>
          <a:ea typeface="+mn-ea"/>
          <a:cs typeface="+mn-cs"/>
        </a:defRPr>
      </a:lvl3pPr>
      <a:lvl4pPr marL="1071014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4pPr>
      <a:lvl5pPr marL="1377018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5pPr>
      <a:lvl6pPr marL="1683022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6pPr>
      <a:lvl7pPr marL="1989026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7pPr>
      <a:lvl8pPr marL="2295030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8pPr>
      <a:lvl9pPr marL="2601034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1pPr>
      <a:lvl2pPr marL="306004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2pPr>
      <a:lvl3pPr marL="612008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3pPr>
      <a:lvl4pPr marL="918012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4pPr>
      <a:lvl5pPr marL="1224016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5pPr>
      <a:lvl6pPr marL="1530020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6pPr>
      <a:lvl7pPr marL="1836024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7pPr>
      <a:lvl8pPr marL="2142028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8pPr>
      <a:lvl9pPr marL="2448032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 Box 69"/>
          <p:cNvSpPr txBox="1">
            <a:spLocks noChangeArrowheads="1"/>
          </p:cNvSpPr>
          <p:nvPr/>
        </p:nvSpPr>
        <p:spPr bwMode="auto">
          <a:xfrm>
            <a:off x="88900" y="7250112"/>
            <a:ext cx="5943600" cy="646331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. Lasso-20 individual gene impact.</a:t>
            </a:r>
            <a:r>
              <a:rPr lang="en-US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Cox-proportional hazards models were constructed for each individual Lasso-20 gene. The model included </a:t>
            </a:r>
            <a:r>
              <a:rPr lang="en-US" alt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age</a:t>
            </a:r>
            <a:r>
              <a:rPr lang="en-US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, and </a:t>
            </a:r>
            <a:r>
              <a:rPr lang="en-US" alt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type</a:t>
            </a:r>
            <a:r>
              <a:rPr lang="en-US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(LGG versus GBM) as covariates, which are significant in all models.</a:t>
            </a:r>
            <a:endParaRPr lang="en-US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200" b="1" dirty="0">
                <a:latin typeface="Times New Roman" panose="02020603050405020304" pitchFamily="18" charset="0"/>
                <a:cs typeface="Calibri" panose="020F0502020204030204" pitchFamily="34" charset="0"/>
              </a:rPr>
              <a:t> </a:t>
            </a:r>
            <a:endParaRPr lang="en-US" altLang="en-US" sz="1000" b="1" dirty="0">
              <a:latin typeface="Times New Roman" panose="02020603050405020304" pitchFamily="18" charset="0"/>
              <a:cs typeface="Calibri" panose="020F0502020204030204" pitchFamily="34" charset="0"/>
            </a:endParaRP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11907" y="35009"/>
            <a:ext cx="6119813" cy="706270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202471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6</TotalTime>
  <Words>42</Words>
  <Application>Microsoft Office PowerPoint</Application>
  <PresentationFormat>Custom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GBM-LGG Figures</dc:title>
  <dc:creator>Celiku, Orieta (NIH/NCI) [E]</dc:creator>
  <cp:lastModifiedBy>Celiku, Orieta (NIH/NCI) [E]</cp:lastModifiedBy>
  <cp:revision>42</cp:revision>
  <cp:lastPrinted>2016-07-15T16:41:28Z</cp:lastPrinted>
  <dcterms:created xsi:type="dcterms:W3CDTF">2016-07-15T13:00:09Z</dcterms:created>
  <dcterms:modified xsi:type="dcterms:W3CDTF">2016-07-15T16:48:58Z</dcterms:modified>
</cp:coreProperties>
</file>